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94"/>
  </p:normalViewPr>
  <p:slideViewPr>
    <p:cSldViewPr snapToGrid="0">
      <p:cViewPr varScale="1">
        <p:scale>
          <a:sx n="121" d="100"/>
          <a:sy n="121" d="100"/>
        </p:scale>
        <p:origin x="74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1138C6-3FA4-41C0-E711-E0EEFB593B0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83DFEF3-A3AB-384B-768F-BAEE689081F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8042D7-C052-B182-15F9-3559396E15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8F896-0E7F-7641-92BA-F749F72D8DE6}" type="datetimeFigureOut">
              <a:rPr lang="en-DE" smtClean="0"/>
              <a:t>15.07.25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634A0A-647F-F3F4-DBE0-5F17E85A00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5A3AC6-6C58-DAF7-4F26-C3D228E816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690AF5-028F-084E-9BA9-B58F7AF5B2D2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6723511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FBAEAF-1009-2CEB-497B-0D21FE20D6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60DE4C0-5680-74C9-824B-BA846C249B8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AE41E5-FA1C-850E-6645-E8640CB355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8F896-0E7F-7641-92BA-F749F72D8DE6}" type="datetimeFigureOut">
              <a:rPr lang="en-DE" smtClean="0"/>
              <a:t>15.07.25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27CD69-27EC-202B-4EA8-08E6FB5BD4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F6EA67-3FDC-91E5-07E6-5064ABB891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690AF5-028F-084E-9BA9-B58F7AF5B2D2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7319278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DECA8B0-8204-EA63-D581-705C0FB2E81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A415E5A-E897-EE8F-30B3-DE4359B11EF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5E811C-DC06-48DF-3472-C4AF054C4C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8F896-0E7F-7641-92BA-F749F72D8DE6}" type="datetimeFigureOut">
              <a:rPr lang="en-DE" smtClean="0"/>
              <a:t>15.07.25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52DAEE7-D0DF-7C8B-AD09-0A75A6A134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B13098-532C-3320-E834-E55AEA0668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690AF5-028F-084E-9BA9-B58F7AF5B2D2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1952772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2B250E-925F-A136-5BED-3121DBB951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899CDE1-652A-8D64-1C5E-1FCAF79D21D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81A1E8-1EDD-06D9-61DB-9DC7DD0F9F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8F896-0E7F-7641-92BA-F749F72D8DE6}" type="datetimeFigureOut">
              <a:rPr lang="en-DE" smtClean="0"/>
              <a:t>15.07.25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4AF17F-CA47-14E8-2AF4-F9E664EFC3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6AE823A-47AB-255C-1B84-68AC8B4474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690AF5-028F-084E-9BA9-B58F7AF5B2D2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170319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B5B8E8-EDC3-3320-5233-B98087065C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28DCC3A-A18E-B23D-75FB-BC56A418A2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ED0D6FE-389B-081F-E9AE-BC3E105325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8F896-0E7F-7641-92BA-F749F72D8DE6}" type="datetimeFigureOut">
              <a:rPr lang="en-DE" smtClean="0"/>
              <a:t>15.07.25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8E86CF-CCE6-6D6B-05D4-644A4E2312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C64519-F3AB-B2F4-AA93-364D72774E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690AF5-028F-084E-9BA9-B58F7AF5B2D2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714506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CF46C1-B95C-A6F0-4E48-FFF5120E8D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5E49AD0-7455-5324-42F5-65DE4534529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6818163-8910-A7B6-95BB-3E47A09D0FB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4E78896-122C-99AB-0AD5-BC2085FF8D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8F896-0E7F-7641-92BA-F749F72D8DE6}" type="datetimeFigureOut">
              <a:rPr lang="en-DE" smtClean="0"/>
              <a:t>15.07.25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C93DA97-5CC6-8693-1450-EBC5C8F049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258466E-EBA9-8EFE-D67A-810DF665AF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690AF5-028F-084E-9BA9-B58F7AF5B2D2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1440326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583AA8-8F15-840D-8165-5959C75257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B010454-2297-D121-7936-E901E63C221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68B5394-0490-829B-0DED-9C672057FE2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3FE25CF-CC04-1779-1813-7308C9DAF77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850BBCC-39DF-BC05-6DBF-602BA83B593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D4CFF32-1E5F-54B9-704C-BE9A1A8EDB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8F896-0E7F-7641-92BA-F749F72D8DE6}" type="datetimeFigureOut">
              <a:rPr lang="en-DE" smtClean="0"/>
              <a:t>15.07.25</a:t>
            </a:fld>
            <a:endParaRPr lang="en-D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81341EC-62F1-B2C3-7A84-C514BB226D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386E42C-671E-3DDA-E0D3-145E69AF79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690AF5-028F-084E-9BA9-B58F7AF5B2D2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2050251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48D47C-A360-80E9-893D-2FCC8A7099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A671B94-5BC9-B8FE-2DB2-4F2FBD4E94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8F896-0E7F-7641-92BA-F749F72D8DE6}" type="datetimeFigureOut">
              <a:rPr lang="en-DE" smtClean="0"/>
              <a:t>15.07.25</a:t>
            </a:fld>
            <a:endParaRPr lang="en-D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7F68E48-8F5B-6A4D-8C4B-0A265C8FFF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E1EA2D3-EDB6-B134-8208-10B2B08EB3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690AF5-028F-084E-9BA9-B58F7AF5B2D2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4421635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B5F44C5-0D0F-0AF7-2829-961A239C15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8F896-0E7F-7641-92BA-F749F72D8DE6}" type="datetimeFigureOut">
              <a:rPr lang="en-DE" smtClean="0"/>
              <a:t>15.07.25</a:t>
            </a:fld>
            <a:endParaRPr lang="en-D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66E5A7C-3CEE-F4D1-E6EA-D40606A9B3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A825C0E-2109-AD3E-076A-3D74FE704A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690AF5-028F-084E-9BA9-B58F7AF5B2D2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0841475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B8C409-13FA-98CE-D81C-7B7F62FAF6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32DAA54-D608-9366-438E-4846C10CC35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17575C0-2DEB-D653-E1E4-2B5BE3FD060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B7BCE49-5591-4798-0634-FC56024AE1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8F896-0E7F-7641-92BA-F749F72D8DE6}" type="datetimeFigureOut">
              <a:rPr lang="en-DE" smtClean="0"/>
              <a:t>15.07.25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1E370ED-4D5F-4A0C-F28B-FFAFD37376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397FFAD-744E-4E64-5A49-3DC5DC4C92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690AF5-028F-084E-9BA9-B58F7AF5B2D2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5637447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8322D5-4261-6B40-3F30-B8CD646B54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6F5E2B3-F853-5CB8-02D7-2FB3D055A6D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3EF2F3C-1715-CE18-7CC8-E4C853AA71B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1E9B330-71EE-5EB2-81D7-ECEC090F7F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8F896-0E7F-7641-92BA-F749F72D8DE6}" type="datetimeFigureOut">
              <a:rPr lang="en-DE" smtClean="0"/>
              <a:t>15.07.25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F4B0B98-1F7A-4A56-1F17-DDC910F915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4E9CCAC-C01F-18CB-79C7-8715C04D3B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690AF5-028F-084E-9BA9-B58F7AF5B2D2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964973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47D41D4-9298-A61B-AA86-55052E1E47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E714FA4-C5D9-FDC8-6677-1172AFC340D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2D9529-0C05-56A1-F4DC-BDB7FF64B15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458F896-0E7F-7641-92BA-F749F72D8DE6}" type="datetimeFigureOut">
              <a:rPr lang="en-DE" smtClean="0"/>
              <a:t>15.07.25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86FEE7D-C8C9-0FB0-7A59-B1A5409A2C0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8236D7-367C-5E0A-92FE-028B5A84A52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C690AF5-028F-084E-9BA9-B58F7AF5B2D2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0327671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8330A6F3-B51F-2DE8-37E1-50C294AB90AD}"/>
              </a:ext>
            </a:extLst>
          </p:cNvPr>
          <p:cNvGrpSpPr/>
          <p:nvPr/>
        </p:nvGrpSpPr>
        <p:grpSpPr>
          <a:xfrm>
            <a:off x="3459480" y="1733550"/>
            <a:ext cx="5273040" cy="3390900"/>
            <a:chOff x="0" y="0"/>
            <a:chExt cx="5273040" cy="3390900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ECDECE71-662F-06C9-E35A-0BFFD7652FD6}"/>
                </a:ext>
              </a:extLst>
            </p:cNvPr>
            <p:cNvGrpSpPr/>
            <p:nvPr/>
          </p:nvGrpSpPr>
          <p:grpSpPr>
            <a:xfrm>
              <a:off x="0" y="0"/>
              <a:ext cx="5273040" cy="3390900"/>
              <a:chOff x="0" y="0"/>
              <a:chExt cx="5273040" cy="3390900"/>
            </a:xfrm>
          </p:grpSpPr>
          <p:sp>
            <p:nvSpPr>
              <p:cNvPr id="7" name="Text Box 10">
                <a:extLst>
                  <a:ext uri="{FF2B5EF4-FFF2-40B4-BE49-F238E27FC236}">
                    <a16:creationId xmlns:a16="http://schemas.microsoft.com/office/drawing/2014/main" id="{394B00E9-F1A1-DD7C-E19F-1FD1D18384E3}"/>
                  </a:ext>
                </a:extLst>
              </p:cNvPr>
              <p:cNvSpPr txBox="1"/>
              <p:nvPr/>
            </p:nvSpPr>
            <p:spPr>
              <a:xfrm>
                <a:off x="0" y="2232660"/>
                <a:ext cx="5273040" cy="115824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C572A759-6A51-4108-AA02-DFA0A04FC94B}">
                  <ma14:wrappingTextBoxFlag xmlns:lc="http://schemas.openxmlformats.org/drawingml/2006/lockedCanvas" xmlns:oel="http://schemas.microsoft.com/office/2019/extlst" xmlns:w16cex="http://schemas.microsoft.com/office/word/2018/wordml/cex" xmlns:w16="http://schemas.microsoft.com/office/word/2018/wordml" xmlns:w16sdtdh="http://schemas.microsoft.com/office/word/2020/wordml/sdtdatahash" xmlns:arto="http://schemas.microsoft.com/office/word/2006/arto" xmlns:ma14="http://schemas.microsoft.com/office/mac/drawingml/2011/main" xmlns:w="http://schemas.openxmlformats.org/wordprocessingml/2006/main" xmlns:w10="urn:schemas-microsoft-com:office:word" xmlns:v="urn:schemas-microsoft-com:vml" xmlns:o="urn:schemas-microsoft-com:office:office" xmlns:mv="urn:schemas-microsoft-com:mac:vml" xmlns:mo="http://schemas.microsoft.com/office/mac/office/2008/main" xmlns="" xmlns:wps="http://schemas.microsoft.com/office/word/2010/wordprocessingShape" xmlns:wne="http://schemas.microsoft.com/office/word/2006/wordml" xmlns:wpi="http://schemas.microsoft.com/office/word/2010/wordprocessingInk" xmlns:wpg="http://schemas.microsoft.com/office/word/2010/wordprocessingGroup" xmlns:w16se="http://schemas.microsoft.com/office/word/2015/wordml/symex" xmlns:w16cid="http://schemas.microsoft.com/office/word/2016/wordml/cid" xmlns:w15="http://schemas.microsoft.com/office/word/2012/wordml" xmlns:w14="http://schemas.microsoft.com/office/word/2010/wordml" xmlns:wp="http://schemas.openxmlformats.org/drawingml/2006/wordprocessingDrawing" xmlns:wp14="http://schemas.microsoft.com/office/word/2010/wordprocessingDrawing" xmlns:m="http://schemas.openxmlformats.org/officeDocument/2006/math" xmlns:am3d="http://schemas.microsoft.com/office/drawing/2017/model3d" xmlns:aink="http://schemas.microsoft.com/office/drawing/2016/ink" xmlns:mc="http://schemas.openxmlformats.org/markup-compatibility/2006" xmlns:cx8="http://schemas.microsoft.com/office/drawing/2016/5/14/chartex" xmlns:cx7="http://schemas.microsoft.com/office/drawing/2016/5/13/chartex" xmlns:cx6="http://schemas.microsoft.com/office/drawing/2016/5/12/chartex" xmlns:cx5="http://schemas.microsoft.com/office/drawing/2016/5/11/chartex" xmlns:cx4="http://schemas.microsoft.com/office/drawing/2016/5/10/chartex" xmlns:cx3="http://schemas.microsoft.com/office/drawing/2016/5/9/chartex" xmlns:cx2="http://schemas.microsoft.com/office/drawing/2015/10/21/chartex" xmlns:cx1="http://schemas.microsoft.com/office/drawing/2015/9/8/chartex" xmlns:cx="http://schemas.microsoft.com/office/drawing/2014/chartex" xmlns:wpc="http://schemas.microsoft.com/office/word/2010/wordprocessingCanvas"/>
                </a:ext>
              </a:extLst>
            </p:spPr>
            <p:style>
              <a:lnRef idx="0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>
                  <a:lnSpc>
                    <a:spcPct val="115000"/>
                  </a:lnSpc>
                </a:pPr>
                <a:r>
                  <a:rPr lang="en-AU" sz="1000" b="1" dirty="0">
                    <a:effectLst/>
                    <a:latin typeface="Calibri" panose="020F0502020204030204" pitchFamily="34" charset="0"/>
                    <a:ea typeface="MS Mincho" panose="02020609040205080304" pitchFamily="49" charset="-128"/>
                    <a:cs typeface="Times New Roman" panose="02020603050405020304" pitchFamily="18" charset="0"/>
                  </a:rPr>
                  <a:t>Additional File 5 - SDS-PAGE of supernatant proteins from </a:t>
                </a:r>
                <a:r>
                  <a:rPr lang="en-AU" sz="1000" b="1" i="1" dirty="0">
                    <a:effectLst/>
                    <a:latin typeface="Calibri" panose="020F0502020204030204" pitchFamily="34" charset="0"/>
                    <a:ea typeface="MS Mincho" panose="02020609040205080304" pitchFamily="49" charset="-128"/>
                    <a:cs typeface="Times New Roman" panose="02020603050405020304" pitchFamily="18" charset="0"/>
                  </a:rPr>
                  <a:t>A. </a:t>
                </a:r>
                <a:r>
                  <a:rPr lang="en-AU" sz="1000" b="1" i="1" dirty="0" err="1">
                    <a:effectLst/>
                    <a:latin typeface="Calibri" panose="020F0502020204030204" pitchFamily="34" charset="0"/>
                    <a:ea typeface="MS Mincho" panose="02020609040205080304" pitchFamily="49" charset="-128"/>
                    <a:cs typeface="Times New Roman" panose="02020603050405020304" pitchFamily="18" charset="0"/>
                  </a:rPr>
                  <a:t>niger</a:t>
                </a:r>
                <a:r>
                  <a:rPr lang="en-AU" sz="1000" b="1" dirty="0">
                    <a:effectLst/>
                    <a:latin typeface="Calibri" panose="020F0502020204030204" pitchFamily="34" charset="0"/>
                    <a:ea typeface="MS Mincho" panose="02020609040205080304" pitchFamily="49" charset="-128"/>
                    <a:cs typeface="Times New Roman" panose="02020603050405020304" pitchFamily="18" charset="0"/>
                  </a:rPr>
                  <a:t> strains expressing collagen</a:t>
                </a:r>
                <a:endParaRPr lang="en-DE" sz="1000" dirty="0">
                  <a:effectLst/>
                  <a:latin typeface="Helvetica" pitchFamily="2" charset="0"/>
                  <a:ea typeface="MS Mincho" panose="02020609040205080304" pitchFamily="49" charset="-128"/>
                  <a:cs typeface="Times New Roman" panose="02020603050405020304" pitchFamily="18" charset="0"/>
                </a:endParaRPr>
              </a:p>
              <a:p>
                <a:pPr>
                  <a:lnSpc>
                    <a:spcPct val="115000"/>
                  </a:lnSpc>
                </a:pPr>
                <a:r>
                  <a:rPr lang="en-AU" sz="1000" dirty="0">
                    <a:effectLst/>
                    <a:latin typeface="Calibri" panose="020F0502020204030204" pitchFamily="34" charset="0"/>
                    <a:ea typeface="MS Mincho" panose="02020609040205080304" pitchFamily="49" charset="-128"/>
                    <a:cs typeface="Times New Roman" panose="02020603050405020304" pitchFamily="18" charset="0"/>
                  </a:rPr>
                  <a:t>Total supernatant (20µl) boiled at 95°C for 5 minutes in reducing conditions and proteins separated by electrophoresis at 200V for 1 hour. Gels stained for 30 minutes in Coomassie G using heat and de-stained until bands were visible. NC is the progenitor strain </a:t>
                </a:r>
                <a:r>
                  <a:rPr lang="en-AU" sz="1000" i="1" dirty="0">
                    <a:effectLst/>
                    <a:latin typeface="Calibri" panose="020F0502020204030204" pitchFamily="34" charset="0"/>
                    <a:ea typeface="MS Mincho" panose="02020609040205080304" pitchFamily="49" charset="-128"/>
                    <a:cs typeface="Times New Roman" panose="02020603050405020304" pitchFamily="18" charset="0"/>
                  </a:rPr>
                  <a:t>ΔgaaB-Mg</a:t>
                </a:r>
                <a:r>
                  <a:rPr lang="en-AU" sz="1000" dirty="0">
                    <a:effectLst/>
                    <a:latin typeface="Calibri" panose="020F0502020204030204" pitchFamily="34" charset="0"/>
                    <a:ea typeface="MS Mincho" panose="02020609040205080304" pitchFamily="49" charset="-128"/>
                    <a:cs typeface="Times New Roman" panose="02020603050405020304" pitchFamily="18" charset="0"/>
                  </a:rPr>
                  <a:t>-17.2. BSA was dissolved in 20µL 1xPBS. The putative collagen band corresponding to a triple helix is highlighted with the red arrow.</a:t>
                </a:r>
                <a:endParaRPr lang="en-DE" sz="1000" dirty="0">
                  <a:effectLst/>
                  <a:latin typeface="Helvetica" pitchFamily="2" charset="0"/>
                  <a:ea typeface="MS Mincho" panose="02020609040205080304" pitchFamily="49" charset="-128"/>
                  <a:cs typeface="Times New Roman" panose="02020603050405020304" pitchFamily="18" charset="0"/>
                </a:endParaRPr>
              </a:p>
              <a:p>
                <a:pPr>
                  <a:lnSpc>
                    <a:spcPct val="115000"/>
                  </a:lnSpc>
                </a:pPr>
                <a:r>
                  <a:rPr lang="en-US" sz="1000" dirty="0">
                    <a:effectLst/>
                    <a:latin typeface="Calibri" panose="020F0502020204030204" pitchFamily="34" charset="0"/>
                    <a:ea typeface="MS Mincho" panose="02020609040205080304" pitchFamily="49" charset="-128"/>
                    <a:cs typeface="Times New Roman" panose="02020603050405020304" pitchFamily="18" charset="0"/>
                  </a:rPr>
                  <a:t> </a:t>
                </a:r>
                <a:endParaRPr lang="en-DE" sz="1000" dirty="0">
                  <a:effectLst/>
                  <a:latin typeface="Helvetica" pitchFamily="2" charset="0"/>
                  <a:ea typeface="MS Mincho" panose="02020609040205080304" pitchFamily="49" charset="-128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9E13DDF1-70EE-0621-C257-A08697BD12B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586740" y="0"/>
                <a:ext cx="3878580" cy="2141220"/>
              </a:xfrm>
              <a:prstGeom prst="rect">
                <a:avLst/>
              </a:prstGeom>
            </p:spPr>
          </p:pic>
        </p:grpSp>
        <p:cxnSp>
          <p:nvCxnSpPr>
            <p:cNvPr id="6" name="Straight Arrow Connector 5">
              <a:extLst>
                <a:ext uri="{FF2B5EF4-FFF2-40B4-BE49-F238E27FC236}">
                  <a16:creationId xmlns:a16="http://schemas.microsoft.com/office/drawing/2014/main" id="{759B3E3C-6696-1BE8-FE9E-4BEDE59549DD}"/>
                </a:ext>
              </a:extLst>
            </p:cNvPr>
            <p:cNvCxnSpPr/>
            <p:nvPr/>
          </p:nvCxnSpPr>
          <p:spPr>
            <a:xfrm flipH="1">
              <a:off x="2621280" y="914400"/>
              <a:ext cx="266700" cy="0"/>
            </a:xfrm>
            <a:prstGeom prst="straightConnector1">
              <a:avLst/>
            </a:prstGeom>
            <a:ln>
              <a:solidFill>
                <a:srgbClr val="C00000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6382994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90</Words>
  <Application>Microsoft Macintosh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Helvetica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U-Pseudonym 1517372033116741</dc:creator>
  <cp:lastModifiedBy>TU-Pseudonym 1517372033116741</cp:lastModifiedBy>
  <cp:revision>1</cp:revision>
  <dcterms:created xsi:type="dcterms:W3CDTF">2025-07-15T18:36:59Z</dcterms:created>
  <dcterms:modified xsi:type="dcterms:W3CDTF">2025-07-15T18:38:41Z</dcterms:modified>
</cp:coreProperties>
</file>